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17" d="100"/>
          <a:sy n="117" d="100"/>
        </p:scale>
        <p:origin x="192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416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555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59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932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882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884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505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292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546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70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479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194F35-92EA-1441-AB56-3D05E8C8D94D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3BD2AEC-D6E6-6A43-A9B7-2BA8F76BD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095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6FC7A1EE-6364-AD9B-7495-0B99C88B2FD2}"/>
              </a:ext>
            </a:extLst>
          </p:cNvPr>
          <p:cNvGrpSpPr/>
          <p:nvPr/>
        </p:nvGrpSpPr>
        <p:grpSpPr>
          <a:xfrm>
            <a:off x="1484016" y="2906486"/>
            <a:ext cx="5929155" cy="1687286"/>
            <a:chOff x="533271" y="2468371"/>
            <a:chExt cx="5496274" cy="1517230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E549C35F-D7FF-471B-BAA4-A302971E1B28}"/>
                </a:ext>
              </a:extLst>
            </p:cNvPr>
            <p:cNvGrpSpPr/>
            <p:nvPr/>
          </p:nvGrpSpPr>
          <p:grpSpPr>
            <a:xfrm>
              <a:off x="4179181" y="2468371"/>
              <a:ext cx="1850364" cy="1517230"/>
              <a:chOff x="4498449" y="3902039"/>
              <a:chExt cx="1893033" cy="1578844"/>
            </a:xfrm>
          </p:grpSpPr>
          <p:pic>
            <p:nvPicPr>
              <p:cNvPr id="26" name="Picture 3" descr="C:\Users\OP\Desktop\ST3KO1.tif">
                <a:extLst>
                  <a:ext uri="{FF2B5EF4-FFF2-40B4-BE49-F238E27FC236}">
                    <a16:creationId xmlns:a16="http://schemas.microsoft.com/office/drawing/2014/main" id="{50CD58FF-EEE7-F602-386E-88FDF9F9C6DD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25000"/>
                        </a14:imgEffect>
                        <a14:imgEffect>
                          <a14:saturation sat="90000"/>
                        </a14:imgEffect>
                        <a14:imgEffect>
                          <a14:brightnessContrast bright="3000" contras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98449" y="4200723"/>
                <a:ext cx="1874520" cy="1280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268F34E3-25E9-14C2-6324-C76BE1B964DC}"/>
                  </a:ext>
                </a:extLst>
              </p:cNvPr>
              <p:cNvSpPr txBox="1"/>
              <p:nvPr/>
            </p:nvSpPr>
            <p:spPr>
              <a:xfrm>
                <a:off x="4622893" y="3902039"/>
                <a:ext cx="1768589" cy="3056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TAT3KO Regression</a:t>
                </a:r>
                <a:endParaRPr lang="en-US" sz="11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A231AB9E-D18F-A302-8349-361384673F3A}"/>
                </a:ext>
              </a:extLst>
            </p:cNvPr>
            <p:cNvGrpSpPr/>
            <p:nvPr/>
          </p:nvGrpSpPr>
          <p:grpSpPr>
            <a:xfrm>
              <a:off x="533271" y="2471212"/>
              <a:ext cx="1724922" cy="1500991"/>
              <a:chOff x="306878" y="3895699"/>
              <a:chExt cx="1874520" cy="1583834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A09E4C1-EE4B-BBF4-E87D-D2CC60DC8AA0}"/>
                  </a:ext>
                </a:extLst>
              </p:cNvPr>
              <p:cNvSpPr txBox="1"/>
              <p:nvPr/>
            </p:nvSpPr>
            <p:spPr>
              <a:xfrm>
                <a:off x="456563" y="3895699"/>
                <a:ext cx="1570366" cy="3099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TAT3KO Control</a:t>
                </a:r>
              </a:p>
            </p:txBody>
          </p:sp>
          <p:pic>
            <p:nvPicPr>
              <p:cNvPr id="22" name="Picture 14" descr="F:\Orthotopic Images\Set 32 Stat3\0d.tif">
                <a:extLst>
                  <a:ext uri="{FF2B5EF4-FFF2-40B4-BE49-F238E27FC236}">
                    <a16:creationId xmlns:a16="http://schemas.microsoft.com/office/drawing/2014/main" id="{8DD08071-CE2B-894B-41F5-AC91C48704D1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  <a14:imgEffect>
                          <a14:saturation sat="66000"/>
                        </a14:imgEffect>
                        <a14:imgEffect>
                          <a14:brightnessContrast bright="13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" r="497"/>
              <a:stretch/>
            </p:blipFill>
            <p:spPr bwMode="auto">
              <a:xfrm>
                <a:off x="306878" y="4199373"/>
                <a:ext cx="1874520" cy="1280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5A6126B1-E451-1438-86BE-797B836FA287}"/>
                </a:ext>
              </a:extLst>
            </p:cNvPr>
            <p:cNvGrpSpPr/>
            <p:nvPr/>
          </p:nvGrpSpPr>
          <p:grpSpPr>
            <a:xfrm>
              <a:off x="2135641" y="2469127"/>
              <a:ext cx="2208537" cy="1510923"/>
              <a:chOff x="2186178" y="3890973"/>
              <a:chExt cx="2396053" cy="1588890"/>
            </a:xfrm>
          </p:grpSpPr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DC730F3-58C5-4D46-ED88-D54D0D9B0D21}"/>
                  </a:ext>
                </a:extLst>
              </p:cNvPr>
              <p:cNvSpPr txBox="1"/>
              <p:nvPr/>
            </p:nvSpPr>
            <p:spPr>
              <a:xfrm>
                <a:off x="2186178" y="3890973"/>
                <a:ext cx="2396053" cy="3089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TAT3KO Partial Regression</a:t>
                </a:r>
                <a:endParaRPr lang="en-US" sz="11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" name="Picture 5" descr="C:\Users\OP\Desktop\ST3KO 2.tif">
                <a:extLst>
                  <a:ext uri="{FF2B5EF4-FFF2-40B4-BE49-F238E27FC236}">
                    <a16:creationId xmlns:a16="http://schemas.microsoft.com/office/drawing/2014/main" id="{896D4358-E6F3-AD62-FDC3-22190328A4C6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25000"/>
                        </a14:imgEffect>
                        <a14:imgEffect>
                          <a14:saturation sat="90000"/>
                        </a14:imgEffect>
                        <a14:imgEffect>
                          <a14:brightnessContrast bright="3000" contras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05042" y="4199703"/>
                <a:ext cx="1874520" cy="1280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DBA31C0C-5B6F-3CD5-467A-E0239F3DDE1A}"/>
              </a:ext>
            </a:extLst>
          </p:cNvPr>
          <p:cNvSpPr txBox="1"/>
          <p:nvPr/>
        </p:nvSpPr>
        <p:spPr>
          <a:xfrm>
            <a:off x="1317172" y="1295400"/>
            <a:ext cx="21930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umor images are in Figure</a:t>
            </a:r>
          </a:p>
        </p:txBody>
      </p:sp>
    </p:spTree>
    <p:extLst>
      <p:ext uri="{BB962C8B-B14F-4D97-AF65-F5344CB8AC3E}">
        <p14:creationId xmlns:p14="http://schemas.microsoft.com/office/powerpoint/2010/main" val="2072775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4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1</cp:revision>
  <dcterms:created xsi:type="dcterms:W3CDTF">2025-06-10T19:15:23Z</dcterms:created>
  <dcterms:modified xsi:type="dcterms:W3CDTF">2025-06-10T19:17:40Z</dcterms:modified>
</cp:coreProperties>
</file>